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ink/ink1.xml" ContentType="application/inkml+xml"/>
  <Override PartName="/ppt/ink/ink2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56" r:id="rId2"/>
    <p:sldId id="301" r:id="rId3"/>
    <p:sldId id="297" r:id="rId4"/>
    <p:sldId id="298" r:id="rId5"/>
    <p:sldId id="302" r:id="rId6"/>
    <p:sldId id="299" r:id="rId7"/>
    <p:sldId id="300" r:id="rId8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>
        <p:scale>
          <a:sx n="99" d="100"/>
          <a:sy n="99" d="100"/>
        </p:scale>
        <p:origin x="-2784" y="173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8T20:04:36.898"/>
    </inkml:context>
    <inkml:brush xml:id="br0">
      <inkml:brushProperty name="width" value="0.025" units="cm"/>
      <inkml:brushProperty name="height" value="0.025" units="cm"/>
    </inkml:brush>
  </inkml:definitions>
  <inkml:trace contextRef="#ctx0" brushRef="#br0">662 118 24575,'5'0'0,"0"0"0,0-1 0,0 0 0,0-1 0,0 1 0,-1-1 0,0 0 0,5-2 0,6-2 0,183-67 0,-140 53 0,-55 19 0,5-2 0,-13 4 0,-166 44-308,3-3-884,4 8 811,128-35 340,30-11 41,6-4 0,0 0 0,-1 0 0,1 0 0,0 0 0,0 0 0,0 0 0,0 0 0,0 0 0,0 0 0,0 0 0,0 0 0,0 0 0,0 0 0,0 0 0,0 0 0,0 1 0,0-1 0,0 0 0,0 0 0,0 0 0,0 0 0,0 0 0,0 0 0,0 0 0,0 0 0,0 0 0,0 0 0,0 0 0,0 0 0,0 0 0,0 0 0,0 0 0,0 0 0,0 0 0,0 0 0,0 0 0,0 0 0,0 0 0,0 0 0,0 0 0,0 0 0,0 0 0,1 0 0,-1 0 0,0 0 0,0 0 0,0 0 0,0 0 0,0 0 0,0 0 0,0 0 0,0 0 0,0 0 0,0 0 0,0 0 0,0 0 0,0 0 0,0 0 0,0 0 0,0 0 0,0 0 0,0 0 0,0 0 0,0 0 0,0 0 0,0 0 0,4 0 0,2 0 0,-2 0 0,6-2 0,197-42 285,-131 27-132,260-62 155,-327 77-276,2-1-32,-8 3 0,-1-1 0,1 1 0,0 0 0,-1-2 0,0 2 0,1-1 0,-1-1 0,4 0 0,-6 0 0,-4 2 0,-6 1 277,0 1 0,-17 3 0,20-3-160,-408 120-986,311-90 1008,70-21-139,-2-1 0,-41 19 0,69-25 0,8-4 0,0 0 0,0 0 0,0 0 0,0 0 0,0 0 0,0 0 0,0 0 0,0 0 0,0 0 0,0 0 0,0 0 0,0 0 0,0 0 0,0 0 0,0 0 0,0 0 0,0 0 0,0 0 0,0 0 0,0 0 0,0 0 0,0 0 0,0 0 0,0 0 0,0 0 0,0 1 0,0-1 0,0 0 0,0 0 0,0 0 0,0 0 0,0 0 0,0 0 0,0 0 0,0 0 0,0 0 0,0 0 0,0 0 0,0 0 0,0 0 0,0 0 0,0 0 0,0 1 0,0-1 0,0 0 0,0 0 0,0 0 0,0 0 0,0 0 0,0 0 0,0 0 0,0 0 0,0 0 0,0 0 0,0 0 0,0 0 0,0 0 0,0 0 0,0 0 0,0 0 0,0 0 0,0 0 0,2 0 0,0 0 0,0 0 0,-1 0 0,2 0 0,1-2 0,138-40-55,-115 32-49,17-5-294,243-82-1,-185 64 1132,-101 33-706,14-4 94,-15 3-121,0 2-2,-9 2 3,-214 79-98,53-29-166,-70 27 40,207-66 223,25-9 0,8-5 0,0 0 0,0 0 0,0 0 0,0 0 0,0 0 0,0 0 0,0 0 0,0 0 0,0 0 0,-1 0 0,1 0 0,0 0 0,0 0 0,0 0 0,0 0 0,0 0 0,0 0 0,0 0 0,0 0 0,0 1 0,0-1 0,0 0 0,0 0 0,0 0 0,0 0 0,0 0 0,0 0 0,0 0 0,0 0 0,0 0 0,0 1 0,0-1 0,0 0 0,0 0 0,0 0 0,0 0 0,0 0 0,0 0 0,0 0 0,0 0 0,0 0 0,0 0 0,1 0 0,-1 0 0,0 0 0,0 0 0,0 0 0,0 0 0,0 0 0,0 0 0,0 0 0,0 0 0,0 0 0,0 0 0,3 0 0,-2 1 0,2-1 0,-1 0 0,0 0 0,0 0 0,2-1 0,117-22 0,-118 21 0,257-66-94,0-1-78,3 18 79,-217 46 93,-189 29 1902,106-16-1860,-486 115-1080,498-116 1004,-15 2-193,-46 20 1,68-20 226,14-6 0,4-3 0,0 0 0,0 0 0,0 1 0,0-1 0,0 0 0,0 0 0,0 0 0,0 0 0,0 0 0,0 0 0,0 0 0,0 0 0,0 0 0,0 0 0,0 0 0,0 0 0,1 0 0,-1 0 0,0 0 0,0 1 0,0-1 0,0 0 0,0 0 0,0 0 0,0 0 0,0 0 0,0 0 0,1 0 0,-1 0 0,0 0 0,0 0 0,0 0 0,0 0 0,12 2 0,4-4 0,-1 0 0,0-1 0,18-5 0,-20 4 0,98-23-90,117-30-4,0 14 183,-214 42 11,33-6 202,-40 4-302,-17 4 0,-40 7-27,-64 19 1,-47 24-1400,148-47 1187,-442 141-2061,414-132 2050,-1 0 71,-55 23-1,93-34 297,1 0-1,-1 1 0,-5 1 0,5 2 640,4-6-734,0 0 1,0 0-1,0 0 0,0 0 0,0 0 1,0 1-1,1-1 0,-1 0 0,0 0 0,0 0 1,0 0-1,0 0 0,0 0 0,0 0 1,0 0-1,0 0 0,0 0 0,0 0 0,0 0 1,0 0-1,0 1 0,0-1 0,0 0 1,0 0-1,0 0 0,0 0 0,0 0 1,1 0-1,-1 0 0,0 0 0,0 0 0,0 0 1,0 0-1,2 1 80,0-1-1,-1 0 1,0 0 0,2 0 0,-1 0-1,-1 0 1,3-1 0,9-2-102,18-6 0,49-19-47,35-16-141,-105 41 116,401-146-1811,-291 111 1086,186-34-1,-260 64 767,0 2-1,53 0 1,-77 7 1247,-21 0-304,-4 1-175,-8 0 558,-171 35 1188,68-13-3223,-466 129-4152,446-107 4798,129-44 184,-1 0 1,1 1-1,0 0 1,-1 0-1,1 0 0,0 0 1,-8 8-1,12-10-55,1-1 0,0 0 0,-1 1 0,0 0 0,1 0 0,-1-1 0,1 1 0,0-1-1,0 2 1,0-2 0,-1 1 0,1-1 0,0 2 0,0-2 1,0 1 0,0-1-1,0 0 1,0 0 0,0 0 0,0 1-1,0-1 1,0 1 0,0-1 0,1 0-1,-1 0 1,0 0 0,0 0 0,0 1-1,0-1 1,0 0 0,0 1 0,1-1-1,-1 0 1,0 1 0,1-1 0,-1 0-1,1 0 1,0 1 61,1-1 0,-1 0 0,1 1 0,-1-1-1,2 1 1,-2-1 0,1 0 0,-1 0 0,1 0 0,0 0 0,2-1-1,19-2 786,-1-1-1,33-12 1,-32 9-902,85-25-377,297-63-1441,8 29 596,-396 64 1242,27-5 0,-48 7-100,-9 0 598,-208 37 1501,186-29-1740,-337 77-2006,12 34 1069,337-110 639,1 1 1,-21 13 0,41-22 85,0-1 1,0 2 0,0-1 0,0 1 0,0-1-1,1 1 1,-1-1 0,0 1 0,0 0 0,1 0-1,-1 0 1,2 0 0,-4 3 0,4-5-27,0 1 0,0-1 0,0 1 1,0-1-1,0 0 0,0 0 0,0 0 0,0 1 0,0-1 1,0 1-1,0-1 0,0 1 0,0-1 0,0 0 0,0 0 0,0 0 1,0 1-1,0-1 0,0 0 0,1 0 0,-1 0 0,0 2 1,0-2-1,0 0 0,0 0 0,0 0 0,0 0 0,2 1 1,-2-1-1,0 0 0,1 0 68,-1 1 1,2-1-1,-1 0 1,-1 1-1,1-1 1,0 0 0,0 0-1,0 0 1,0 0-1,0 0 1,1 0-1,7-2 30,-1 1 0,1-2 0,-1 0 0,1 1 0,-2-2 0,11-5 0,-3 2 36,64-30-22,32-12-1158,231-68 0,73 31 915,-450 94 110,9-1 0,-586 150-1163,11 24-2644,513-154 3523,83-24 291,-84 28 136,73-22 927,15-9-1042,1 0 1,0 0-1,0 1 0,-1-1 1,1 0-1,0 0 1,0 0-1,0 0 0,-1 0 1,1 1-1,0-1 1,0 0-1,0 0 0,0 0 1,0 0-1,0 0 1,0 0-1,0 0 0,0 0 1,0 1-1,0-1 1,-1 0-1,1 0 0,0 0 1,0 0-1,0 0 1,0 0-1,0 2 1,0-2-1,0 0 0,0 0 1,0 0-1,0 0 1,0 0-1,0 0 0,0 1 1,0-1-1,1 0 1,-1 0-1,0 0 0,0 0 1,0 1 140,1-1 0,0 0 1,-1 1-1,1-1 1,-1 1-1,1-1 0,0 0 1,0 0-1,-1 0 0,1 0 1,0 0-1,10 0 276,-2 0 0,0-2 0,1 1 0,12-3 0,-17 3-280,59-14 194,27-10-773,40-14-1241,52-16 462,840-209-2704,-918 240 3897,-41 11-135,-28 7-542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08T20:04:36.899"/>
    </inkml:context>
    <inkml:brush xml:id="br0">
      <inkml:brushProperty name="width" value="0.025" units="cm"/>
      <inkml:brushProperty name="height" value="0.025" units="cm"/>
    </inkml:brush>
  </inkml:definitions>
  <inkml:trace contextRef="#ctx0" brushRef="#br0">1 0 24575,'180'9'0,"12"11"0,355-12 0,-255-35 0,-385 57 0,-280 45 0,258-55 0,106-18 0,-10 1 0,0 1 0,1 0 0,-22 9 0,39-13 0,0 0 0,1 1 0,0-1 0,-1 0 0,1 0 0,-1 0 0,0 0 0,0 0 0,1 1 0,0-1 0,-1 1 0,0-1 0,1 0 0,0 0 0,-1 1 0,1 0 0,-1-1 0,1 0 0,-1 1 0,1-1 0,0 1 0,0 0 0,-1-1 0,1 1 0,0-1 0,0 1 0,0 0 0,0-1 0,-2 1 0,2 0 0,0 0 0,2 0 0,-1 0 0,-1 1 0,1-2 0,1 1 0,-2 0 0,2 0 0,-2 0 0,2-1 0,-1 2 0,0-2 0,0 0 0,1 1 0,-1-1 0,0 0 0,2 2 0,27 6 0,0-1 0,59 7 0,-27-6 0,7 2 0,77 15 0,-140-23 0,-2-2 0,0 1 0,0 0 0,-1 0 0,1 0 0,0 0 0,-1 1 0,0-1 0,1 1 0,-1 0 0,5 4 0,-7-6 0,-1 0 0,0 0 0,0 1 0,0-1 0,0 1 0,0-1 0,0 0 0,0 1 0,0-1 0,0 0 0,0 0 0,0 1 0,0-1 0,0 0 0,0 1 0,0-1 0,0 1 0,0-1 0,0 0 0,0 0 0,0 0 0,0 1 0,0-1 0,0 1 0,-1-1 0,1 0 0,0 1 0,0-1 0,0 0 0,0 0 0,0 0 0,-2 0 0,2 0 0,0 1 0,0-1 0,0 0 0,0 0 0,-1 0 0,1 0 0,0 0 0,0 0 0,0 0 0,-1 0 0,1 0 0,-1 0 0,1 1 0,-1-1 0,1 0 0,0 0 0,-21 6 0,19-6 0,-57 14 0,-82 19 0,108-23 0,1 0 0,-38 21 0,66-29 0,-1 0 0,0 1 0,0 0 0,1 0 0,-1 1 0,0-1 0,1 1 0,-5 6 0,8-8 0,0-1 0,0 1 0,1-1 0,-1 0 0,0 1 0,1-1 0,0 1 0,-1-1 0,1 1 0,-1-1 0,1 1 0,0-1 0,0 1 0,0-1 0,0 1 0,0 0 0,0-1 0,0 1 0,1-1 0,-1 1 0,1 0 0,-1-1 0,1 1 0,0-1 0,-1 1 0,1-1 0,0 0 0,0 0 0,-1 0 0,2 1 0,-1-1 0,0 0 0,2 2 0,17 17 0,1-1 0,1 0 0,1-1 0,0-1 0,1-3 0,33 17 0,-32-21 0,-18-7 0,-1-1 0,0 1 0,0-1 0,-1 2 0,2-1 0,-2 0 0,7 7 0,-11-10 0,-1 2 0,1-2 0,-1 0 0,0 1 0,0-1 0,1 0 0,-1 1 0,0 0 0,1-1 0,-1 1 0,0-1 0,0 1 0,0 0 0,0-1 0,0 1 0,0-1 0,0 1 0,0 0 0,0-1 0,0 1 0,0-1 0,0 1 0,0-1 0,0 0 0,0 1 0,-1 0 0,1 0 0,0-1 0,-1 0 0,1 1 0,0 0 0,0-1 0,0 1 0,-1-1 0,0 0 0,1 1 0,-1-1 0,1 1 0,0-1 0,-1 1 0,1-1 0,0 0 0,-2 0 0,-25 15 0,23-13 0,0 0 0,0 0 0,0 0 0,0 0 0,0 1 0,1 0 0,-1 0 0,1 0 0,0-1 0,-6 8 0,7-7 0,1-1 0,1 0 0,-2 0 0,1 1 0,1-2 0,-1 2 0,0-1 0,0 1 0,1-1 0,0 0 0,0 1 0,0-1 0,0 0 0,0 1 0,0-1 0,0 0 0,0 1 0,1-1 0,0 1 0,1 3 0,1 0 0,0 1 0,0-2 0,0 0 0,1 0 0,0 1 0,6 5 0,-5-6 0,-1 0 0,0 1 0,0 0 0,0-1 0,3 9 0,-6-12 0,-1 0 0,1-1 0,-1 0 0,0 2 0,1-2 0,-1 1 0,0 0 0,0-1 0,0 2 0,0-2 0,0 0 0,0 1 0,-1 0 0,1 0 0,0 0 0,-1-1 0,1 0 0,-1 1 0,0 0 0,1-1 0,-1 1 0,0-1 0,0 1 0,-2 1 0,-3 3 0,0 0 0,0-1 0,0 1 0,-10 4 0,11-7 0,1 0 0,-1 1 0,1-1 0,0 1 0,0 0 0,-8 9 0,9-8 11,2 0 0,-1 0 0,0 0 0,0 1 0,1-1 0,0 1-1,1-2 1,-1 2 0,1 0 0,0 5 0,1 3-506,0 1 0,6 22 0,-1-10-633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46E591-BE1C-41BC-A5D7-E8A0C1B67C5A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774854-7804-486D-9557-38C535CD6A1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6361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06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46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512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996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511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463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577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079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082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83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734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3B069-EEED-4199-BFBF-27274735A5C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27D32-DCDB-4E0A-84F3-8C714A182AFE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666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3.emf"/><Relationship Id="rId18" Type="http://schemas.openxmlformats.org/officeDocument/2006/relationships/oleObject" Target="../embeddings/oleObject5.bin"/><Relationship Id="rId3" Type="http://schemas.openxmlformats.org/officeDocument/2006/relationships/image" Target="../media/image8.png"/><Relationship Id="rId21" Type="http://schemas.openxmlformats.org/officeDocument/2006/relationships/image" Target="../media/image7.emf"/><Relationship Id="rId7" Type="http://schemas.openxmlformats.org/officeDocument/2006/relationships/customXml" Target="../ink/ink2.xml"/><Relationship Id="rId12" Type="http://schemas.openxmlformats.org/officeDocument/2006/relationships/oleObject" Target="../embeddings/oleObject2.bin"/><Relationship Id="rId17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4.bin"/><Relationship Id="rId20" Type="http://schemas.openxmlformats.org/officeDocument/2006/relationships/oleObject" Target="../embeddings/oleObject6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30.png"/><Relationship Id="rId11" Type="http://schemas.openxmlformats.org/officeDocument/2006/relationships/image" Target="../media/image2.emf"/><Relationship Id="rId15" Type="http://schemas.openxmlformats.org/officeDocument/2006/relationships/image" Target="../media/image4.emf"/><Relationship Id="rId10" Type="http://schemas.openxmlformats.org/officeDocument/2006/relationships/oleObject" Target="../embeddings/oleObject1.bin"/><Relationship Id="rId19" Type="http://schemas.openxmlformats.org/officeDocument/2006/relationships/image" Target="../media/image6.emf"/><Relationship Id="rId4" Type="http://schemas.openxmlformats.org/officeDocument/2006/relationships/customXml" Target="../ink/ink1.xml"/><Relationship Id="rId9" Type="http://schemas.openxmlformats.org/officeDocument/2006/relationships/image" Target="../media/image9.png"/><Relationship Id="rId1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2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xmlns="" id="{9E78DDC9-9274-06E4-233E-E782E65A4BA0}"/>
              </a:ext>
            </a:extLst>
          </p:cNvPr>
          <p:cNvSpPr txBox="1"/>
          <p:nvPr/>
        </p:nvSpPr>
        <p:spPr>
          <a:xfrm>
            <a:off x="2241442" y="5911334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Figur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30235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xmlns="" id="{BFCDC7C4-8947-CE05-7440-DE435271545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4544177"/>
              </p:ext>
            </p:extLst>
          </p:nvPr>
        </p:nvGraphicFramePr>
        <p:xfrm>
          <a:off x="626110" y="1520662"/>
          <a:ext cx="5880680" cy="158580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590741">
                  <a:extLst>
                    <a:ext uri="{9D8B030D-6E8A-4147-A177-3AD203B41FA5}">
                      <a16:colId xmlns:a16="http://schemas.microsoft.com/office/drawing/2014/main" xmlns="" val="3673662373"/>
                    </a:ext>
                  </a:extLst>
                </a:gridCol>
                <a:gridCol w="1488156">
                  <a:extLst>
                    <a:ext uri="{9D8B030D-6E8A-4147-A177-3AD203B41FA5}">
                      <a16:colId xmlns:a16="http://schemas.microsoft.com/office/drawing/2014/main" xmlns="" val="1003228843"/>
                    </a:ext>
                  </a:extLst>
                </a:gridCol>
                <a:gridCol w="1488156">
                  <a:extLst>
                    <a:ext uri="{9D8B030D-6E8A-4147-A177-3AD203B41FA5}">
                      <a16:colId xmlns:a16="http://schemas.microsoft.com/office/drawing/2014/main" xmlns="" val="3604393947"/>
                    </a:ext>
                  </a:extLst>
                </a:gridCol>
                <a:gridCol w="1313627">
                  <a:extLst>
                    <a:ext uri="{9D8B030D-6E8A-4147-A177-3AD203B41FA5}">
                      <a16:colId xmlns:a16="http://schemas.microsoft.com/office/drawing/2014/main" xmlns="" val="715985204"/>
                    </a:ext>
                  </a:extLst>
                </a:gridCol>
              </a:tblGrid>
              <a:tr h="196305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ture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in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59323939"/>
                  </a:ext>
                </a:extLst>
              </a:tr>
              <a:tr h="1963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E-58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E-75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E-125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332552759"/>
                  </a:ext>
                </a:extLst>
              </a:tr>
              <a:tr h="1963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me size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94362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13530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60474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2827609817"/>
                  </a:ext>
                </a:extLst>
              </a:tr>
              <a:tr h="1963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 content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82%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88%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12%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488042906"/>
                  </a:ext>
                </a:extLst>
              </a:tr>
              <a:tr h="40797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with pneumonia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with pneumonia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with pneumonia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2220955450"/>
                  </a:ext>
                </a:extLst>
              </a:tr>
              <a:tr h="1963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ry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xico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xico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xico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3809144825"/>
                  </a:ext>
                </a:extLst>
              </a:tr>
              <a:tr h="19630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lang="es-MX" sz="11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s work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s work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s work</a:t>
                      </a:r>
                      <a:endParaRPr lang="es-MX" sz="11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xmlns="" val="2463926362"/>
                  </a:ext>
                </a:extLst>
              </a:tr>
            </a:tbl>
          </a:graphicData>
        </a:graphic>
      </p:graphicFrame>
      <p:pic>
        <p:nvPicPr>
          <p:cNvPr id="5" name="Imagen 4">
            <a:extLst>
              <a:ext uri="{FF2B5EF4-FFF2-40B4-BE49-F238E27FC236}">
                <a16:creationId xmlns:a16="http://schemas.microsoft.com/office/drawing/2014/main" xmlns="" id="{4E2D37A1-B0B4-C1AE-6860-3DD8957369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997" y="3672288"/>
            <a:ext cx="6189956" cy="3388201"/>
          </a:xfrm>
          <a:prstGeom prst="rect">
            <a:avLst/>
          </a:prstGeom>
          <a:noFill/>
        </p:spPr>
      </p:pic>
      <p:sp>
        <p:nvSpPr>
          <p:cNvPr id="6" name="5 CuadroTexto">
            <a:extLst>
              <a:ext uri="{FF2B5EF4-FFF2-40B4-BE49-F238E27FC236}">
                <a16:creationId xmlns:a16="http://schemas.microsoft.com/office/drawing/2014/main" xmlns="" id="{074D8724-15E4-7A93-B3A4-8E124817F996}"/>
              </a:ext>
            </a:extLst>
          </p:cNvPr>
          <p:cNvSpPr txBox="1"/>
          <p:nvPr/>
        </p:nvSpPr>
        <p:spPr>
          <a:xfrm>
            <a:off x="318977" y="329609"/>
            <a:ext cx="6379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xmlns="" id="{C8260D44-7B2B-40D1-77BF-37D89DF85F61}"/>
              </a:ext>
            </a:extLst>
          </p:cNvPr>
          <p:cNvSpPr txBox="1"/>
          <p:nvPr/>
        </p:nvSpPr>
        <p:spPr>
          <a:xfrm>
            <a:off x="626110" y="7694761"/>
            <a:ext cx="5880679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A) Information about th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DR strains used. All strains from Dr. Rosario Morales Espinosa's (RME) collection are derived from clinical isolates of pneumonia patients at CMN SXXI Hospital in Mexico City; however, genomic data is only available for strains RME-58, 75, and 125. The first two strains were employed for the isolation of resistant clones to phages φDCL-PA6 and φDCL-PA6α, respectively. B) Phylogenetic tree of th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DR strains created with the codon tree method which selects 100 single-copy genes from the BV-BRC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GFam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analyzes aligned proteins and coding DNA sequences using the program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AxM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ersion 8.2.11. Species were selected based on their belonging to either clade PAO1 or PA14.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RFPA04 belongs to the PA14 clade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K2 to the PAO1 clade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ubed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D., Vijay, A.K., Kohli, G.S. et al. Comparative genomics of clinical strains of Pseudomonas aeruginosa strains isolated from different geographic sites. Sci Rep 8, 15668 (2018). https://doi.org/10.1038/s41598-018-34020-7).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7 was used as a taxonomic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utli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ME-58 and RME-75 belong to the PA14 clade while RME-125 to the PAO1 clade.</a:t>
            </a:r>
          </a:p>
          <a:p>
            <a:pPr algn="just"/>
            <a:endParaRPr lang="en-US" sz="1000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xmlns="" id="{8C63AE67-ECFD-CB65-D2AC-535BBDFC0D7A}"/>
              </a:ext>
            </a:extLst>
          </p:cNvPr>
          <p:cNvSpPr txBox="1"/>
          <p:nvPr/>
        </p:nvSpPr>
        <p:spPr>
          <a:xfrm>
            <a:off x="609115" y="1086265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xmlns="" id="{38F4CCA8-0287-65A9-B18D-F316B3E4324D}"/>
              </a:ext>
            </a:extLst>
          </p:cNvPr>
          <p:cNvSpPr txBox="1"/>
          <p:nvPr/>
        </p:nvSpPr>
        <p:spPr>
          <a:xfrm>
            <a:off x="618394" y="3805073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638334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>
            <a:extLst>
              <a:ext uri="{FF2B5EF4-FFF2-40B4-BE49-F238E27FC236}">
                <a16:creationId xmlns:a16="http://schemas.microsoft.com/office/drawing/2014/main" xmlns="" id="{286CA4C7-D1EA-9D3F-4750-49F7F0F6E739}"/>
              </a:ext>
            </a:extLst>
          </p:cNvPr>
          <p:cNvGrpSpPr/>
          <p:nvPr/>
        </p:nvGrpSpPr>
        <p:grpSpPr>
          <a:xfrm>
            <a:off x="0" y="1268096"/>
            <a:ext cx="6858000" cy="2882131"/>
            <a:chOff x="144773" y="4630615"/>
            <a:chExt cx="6434132" cy="2740390"/>
          </a:xfrm>
        </p:grpSpPr>
        <p:grpSp>
          <p:nvGrpSpPr>
            <p:cNvPr id="6" name="Grupo 5">
              <a:extLst>
                <a:ext uri="{FF2B5EF4-FFF2-40B4-BE49-F238E27FC236}">
                  <a16:creationId xmlns:a16="http://schemas.microsoft.com/office/drawing/2014/main" xmlns="" id="{B061BA7B-25E9-9765-8E76-9B7129DA9EEE}"/>
                </a:ext>
              </a:extLst>
            </p:cNvPr>
            <p:cNvGrpSpPr/>
            <p:nvPr/>
          </p:nvGrpSpPr>
          <p:grpSpPr>
            <a:xfrm>
              <a:off x="144773" y="4797009"/>
              <a:ext cx="6434132" cy="2304509"/>
              <a:chOff x="154902" y="1030160"/>
              <a:chExt cx="11438457" cy="4096905"/>
            </a:xfrm>
          </p:grpSpPr>
          <p:grpSp>
            <p:nvGrpSpPr>
              <p:cNvPr id="16" name="Grupo 15">
                <a:extLst>
                  <a:ext uri="{FF2B5EF4-FFF2-40B4-BE49-F238E27FC236}">
                    <a16:creationId xmlns:a16="http://schemas.microsoft.com/office/drawing/2014/main" xmlns="" id="{D492318F-0E09-9768-15D3-D7123253F898}"/>
                  </a:ext>
                </a:extLst>
              </p:cNvPr>
              <p:cNvGrpSpPr/>
              <p:nvPr/>
            </p:nvGrpSpPr>
            <p:grpSpPr>
              <a:xfrm>
                <a:off x="154902" y="1030160"/>
                <a:ext cx="11438457" cy="4096905"/>
                <a:chOff x="154902" y="1030160"/>
                <a:chExt cx="11438457" cy="4096905"/>
              </a:xfrm>
            </p:grpSpPr>
            <p:grpSp>
              <p:nvGrpSpPr>
                <p:cNvPr id="22" name="Grupo 21">
                  <a:extLst>
                    <a:ext uri="{FF2B5EF4-FFF2-40B4-BE49-F238E27FC236}">
                      <a16:creationId xmlns:a16="http://schemas.microsoft.com/office/drawing/2014/main" xmlns="" id="{9E3FFB50-D51B-0734-BECE-CF16204C1D96}"/>
                    </a:ext>
                  </a:extLst>
                </p:cNvPr>
                <p:cNvGrpSpPr/>
                <p:nvPr/>
              </p:nvGrpSpPr>
              <p:grpSpPr>
                <a:xfrm>
                  <a:off x="154902" y="1255498"/>
                  <a:ext cx="10641385" cy="3871567"/>
                  <a:chOff x="4515843" y="3206565"/>
                  <a:chExt cx="2876301" cy="1010041"/>
                </a:xfrm>
              </p:grpSpPr>
              <p:pic>
                <p:nvPicPr>
                  <p:cNvPr id="27" name="Imagen 26">
                    <a:extLst>
                      <a:ext uri="{FF2B5EF4-FFF2-40B4-BE49-F238E27FC236}">
                        <a16:creationId xmlns:a16="http://schemas.microsoft.com/office/drawing/2014/main" xmlns="" id="{E2116425-63F6-FF6F-7C68-C24113E4173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4515843" y="3206565"/>
                    <a:ext cx="905291" cy="686115"/>
                  </a:xfrm>
                  <a:prstGeom prst="rect">
                    <a:avLst/>
                  </a:prstGeom>
                </p:spPr>
              </p:pic>
              <p:grpSp>
                <p:nvGrpSpPr>
                  <p:cNvPr id="28" name="Grupo 27">
                    <a:extLst>
                      <a:ext uri="{FF2B5EF4-FFF2-40B4-BE49-F238E27FC236}">
                        <a16:creationId xmlns:a16="http://schemas.microsoft.com/office/drawing/2014/main" xmlns="" id="{4C5C4187-122B-D62D-3160-16F107018E07}"/>
                      </a:ext>
                    </a:extLst>
                  </p:cNvPr>
                  <p:cNvGrpSpPr/>
                  <p:nvPr/>
                </p:nvGrpSpPr>
                <p:grpSpPr>
                  <a:xfrm>
                    <a:off x="5542932" y="3403171"/>
                    <a:ext cx="411855" cy="457233"/>
                    <a:chOff x="5652764" y="3107730"/>
                    <a:chExt cx="2182130" cy="2327290"/>
                  </a:xfrm>
                </p:grpSpPr>
                <p:grpSp>
                  <p:nvGrpSpPr>
                    <p:cNvPr id="37" name="Grupo 36">
                      <a:extLst>
                        <a:ext uri="{FF2B5EF4-FFF2-40B4-BE49-F238E27FC236}">
                          <a16:creationId xmlns:a16="http://schemas.microsoft.com/office/drawing/2014/main" xmlns="" id="{BC925902-AFFD-2281-BDD0-836D8DA4ACD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652764" y="3601731"/>
                      <a:ext cx="1817557" cy="1833289"/>
                      <a:chOff x="6293599" y="2457134"/>
                      <a:chExt cx="2285055" cy="2279201"/>
                    </a:xfrm>
                  </p:grpSpPr>
                  <p:sp>
                    <p:nvSpPr>
                      <p:cNvPr id="41" name="Elipse 40">
                        <a:extLst>
                          <a:ext uri="{FF2B5EF4-FFF2-40B4-BE49-F238E27FC236}">
                            <a16:creationId xmlns:a16="http://schemas.microsoft.com/office/drawing/2014/main" xmlns="" id="{A64F0F21-708B-346B-C85C-F874D8C52D2A}"/>
                          </a:ext>
                        </a:extLst>
                      </p:cNvPr>
                      <p:cNvSpPr/>
                      <p:nvPr/>
                    </p:nvSpPr>
                    <p:spPr>
                      <a:xfrm rot="11016783">
                        <a:off x="6293599" y="2457134"/>
                        <a:ext cx="2285055" cy="2279201"/>
                      </a:xfrm>
                      <a:prstGeom prst="ellipse">
                        <a:avLst/>
                      </a:prstGeom>
                    </p:spPr>
                    <p:style>
                      <a:lnRef idx="2">
                        <a:schemeClr val="dk1"/>
                      </a:lnRef>
                      <a:fillRef idx="1">
                        <a:schemeClr val="lt1"/>
                      </a:fillRef>
                      <a:effectRef idx="0">
                        <a:schemeClr val="dk1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42" name="Elipse 41">
                        <a:extLst>
                          <a:ext uri="{FF2B5EF4-FFF2-40B4-BE49-F238E27FC236}">
                            <a16:creationId xmlns:a16="http://schemas.microsoft.com/office/drawing/2014/main" xmlns="" id="{AFD98830-CDB1-0F44-1C54-18A74CC66CEB}"/>
                          </a:ext>
                        </a:extLst>
                      </p:cNvPr>
                      <p:cNvSpPr/>
                      <p:nvPr/>
                    </p:nvSpPr>
                    <p:spPr>
                      <a:xfrm rot="11016783">
                        <a:off x="6389699" y="2548546"/>
                        <a:ext cx="2081719" cy="2096376"/>
                      </a:xfrm>
                      <a:prstGeom prst="ellipse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</p:spPr>
                    <p:style>
                      <a:lnRef idx="2">
                        <a:schemeClr val="accent6"/>
                      </a:lnRef>
                      <a:fillRef idx="1">
                        <a:schemeClr val="lt1"/>
                      </a:fillRef>
                      <a:effectRef idx="0">
                        <a:schemeClr val="accent6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 dirty="0"/>
                      </a:p>
                    </p:txBody>
                  </p:sp>
                  <p:sp>
                    <p:nvSpPr>
                      <p:cNvPr id="43" name="Elipse 42">
                        <a:extLst>
                          <a:ext uri="{FF2B5EF4-FFF2-40B4-BE49-F238E27FC236}">
                            <a16:creationId xmlns:a16="http://schemas.microsoft.com/office/drawing/2014/main" xmlns="" id="{42D314EF-1C3E-DD57-4C6A-EB6A2E01135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835759" y="2890553"/>
                        <a:ext cx="530263" cy="538447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 dirty="0"/>
                      </a:p>
                    </p:txBody>
                  </p:sp>
                  <p:sp>
                    <p:nvSpPr>
                      <p:cNvPr id="44" name="Elipse 43">
                        <a:extLst>
                          <a:ext uri="{FF2B5EF4-FFF2-40B4-BE49-F238E27FC236}">
                            <a16:creationId xmlns:a16="http://schemas.microsoft.com/office/drawing/2014/main" xmlns="" id="{B988C64C-D751-8F5B-06BF-804F9D3354E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556800" y="2890553"/>
                        <a:ext cx="530263" cy="538447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45" name="Elipse 44">
                        <a:extLst>
                          <a:ext uri="{FF2B5EF4-FFF2-40B4-BE49-F238E27FC236}">
                            <a16:creationId xmlns:a16="http://schemas.microsoft.com/office/drawing/2014/main" xmlns="" id="{74E9BA04-4E8A-B1DB-6749-0AD0D054467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6835759" y="3674555"/>
                        <a:ext cx="530263" cy="538447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46" name="Elipse 45">
                        <a:extLst>
                          <a:ext uri="{FF2B5EF4-FFF2-40B4-BE49-F238E27FC236}">
                            <a16:creationId xmlns:a16="http://schemas.microsoft.com/office/drawing/2014/main" xmlns="" id="{F15222AD-6CAA-C912-7C3E-60246F7D9BA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540095" y="3675923"/>
                        <a:ext cx="530263" cy="538447"/>
                      </a:xfrm>
                      <a:prstGeom prst="ellipse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47" name="Elipse 46">
                        <a:extLst>
                          <a:ext uri="{FF2B5EF4-FFF2-40B4-BE49-F238E27FC236}">
                            <a16:creationId xmlns:a16="http://schemas.microsoft.com/office/drawing/2014/main" xmlns="" id="{391A4C0F-A50F-0F16-0FF2-FF87C8F32D7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690598" y="3215495"/>
                        <a:ext cx="45719" cy="45719"/>
                      </a:xfrm>
                      <a:prstGeom prst="ellipse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48" name="Elipse 47">
                        <a:extLst>
                          <a:ext uri="{FF2B5EF4-FFF2-40B4-BE49-F238E27FC236}">
                            <a16:creationId xmlns:a16="http://schemas.microsoft.com/office/drawing/2014/main" xmlns="" id="{8BB9D40F-8622-CC0C-1C25-56EFE3E5455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821931" y="4000137"/>
                        <a:ext cx="45719" cy="45719"/>
                      </a:xfrm>
                      <a:prstGeom prst="ellipse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49" name="Elipse 48">
                        <a:extLst>
                          <a:ext uri="{FF2B5EF4-FFF2-40B4-BE49-F238E27FC236}">
                            <a16:creationId xmlns:a16="http://schemas.microsoft.com/office/drawing/2014/main" xmlns="" id="{1F2B1E72-F6B1-E41C-AA48-B85C83A1755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177254" y="3811657"/>
                        <a:ext cx="45719" cy="45719"/>
                      </a:xfrm>
                      <a:prstGeom prst="ellipse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50" name="Elipse 49">
                        <a:extLst>
                          <a:ext uri="{FF2B5EF4-FFF2-40B4-BE49-F238E27FC236}">
                            <a16:creationId xmlns:a16="http://schemas.microsoft.com/office/drawing/2014/main" xmlns="" id="{222944C2-E42E-6F9F-7743-2A11F6C3286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7010194" y="3027105"/>
                        <a:ext cx="45719" cy="45719"/>
                      </a:xfrm>
                      <a:prstGeom prst="ellipse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sp>
                    <p:nvSpPr>
                      <p:cNvPr id="51" name="Elipse 50">
                        <a:extLst>
                          <a:ext uri="{FF2B5EF4-FFF2-40B4-BE49-F238E27FC236}">
                            <a16:creationId xmlns:a16="http://schemas.microsoft.com/office/drawing/2014/main" xmlns="" id="{593B0703-B092-2CB8-6117-E8E9775B587D}"/>
                          </a:ext>
                        </a:extLst>
                      </p:cNvPr>
                      <p:cNvSpPr/>
                      <p:nvPr/>
                    </p:nvSpPr>
                    <p:spPr>
                      <a:xfrm flipH="1" flipV="1">
                        <a:off x="7935509" y="3136142"/>
                        <a:ext cx="45719" cy="45719"/>
                      </a:xfrm>
                      <a:prstGeom prst="ellipse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</p:grpSp>
                <p:grpSp>
                  <p:nvGrpSpPr>
                    <p:cNvPr id="38" name="Grupo 37">
                      <a:extLst>
                        <a:ext uri="{FF2B5EF4-FFF2-40B4-BE49-F238E27FC236}">
                          <a16:creationId xmlns:a16="http://schemas.microsoft.com/office/drawing/2014/main" xmlns="" id="{49ACFB6E-1C3D-D6E0-44E9-062C4903194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978991" y="3107730"/>
                      <a:ext cx="855903" cy="971549"/>
                      <a:chOff x="8270421" y="3339193"/>
                      <a:chExt cx="855903" cy="971549"/>
                    </a:xfrm>
                  </p:grpSpPr>
                  <p:sp>
                    <p:nvSpPr>
                      <p:cNvPr id="39" name="Elipse 38">
                        <a:extLst>
                          <a:ext uri="{FF2B5EF4-FFF2-40B4-BE49-F238E27FC236}">
                            <a16:creationId xmlns:a16="http://schemas.microsoft.com/office/drawing/2014/main" xmlns="" id="{E5F8FF5D-8808-CE5C-5492-5FB5C9BAB948}"/>
                          </a:ext>
                        </a:extLst>
                      </p:cNvPr>
                      <p:cNvSpPr/>
                      <p:nvPr/>
                    </p:nvSpPr>
                    <p:spPr>
                      <a:xfrm rot="1838764">
                        <a:off x="8270421" y="4147895"/>
                        <a:ext cx="122465" cy="162847"/>
                      </a:xfrm>
                      <a:prstGeom prst="ellipse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 sz="321"/>
                      </a:p>
                    </p:txBody>
                  </p:sp>
                  <p:cxnSp>
                    <p:nvCxnSpPr>
                      <p:cNvPr id="40" name="Conector recto 39">
                        <a:extLst>
                          <a:ext uri="{FF2B5EF4-FFF2-40B4-BE49-F238E27FC236}">
                            <a16:creationId xmlns:a16="http://schemas.microsoft.com/office/drawing/2014/main" xmlns="" id="{BFAD84BE-A3A4-BF78-FAA6-C795451E58AE}"/>
                          </a:ext>
                        </a:extLst>
                      </p:cNvPr>
                      <p:cNvCxnSpPr>
                        <a:stCxn id="39" idx="0"/>
                      </p:cNvCxnSpPr>
                      <p:nvPr/>
                    </p:nvCxnSpPr>
                    <p:spPr>
                      <a:xfrm flipV="1">
                        <a:off x="8373158" y="3339193"/>
                        <a:ext cx="753166" cy="820074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29" name="Elipse 28">
                    <a:extLst>
                      <a:ext uri="{FF2B5EF4-FFF2-40B4-BE49-F238E27FC236}">
                        <a16:creationId xmlns:a16="http://schemas.microsoft.com/office/drawing/2014/main" xmlns="" id="{22FAE6BD-AB62-91E3-8100-DA3EA2406EE7}"/>
                      </a:ext>
                    </a:extLst>
                  </p:cNvPr>
                  <p:cNvSpPr/>
                  <p:nvPr/>
                </p:nvSpPr>
                <p:spPr>
                  <a:xfrm>
                    <a:off x="6241219" y="3463267"/>
                    <a:ext cx="379228" cy="381081"/>
                  </a:xfrm>
                  <a:prstGeom prst="ellipse">
                    <a:avLst/>
                  </a:prstGeom>
                  <a:noFill/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321"/>
                  </a:p>
                </p:txBody>
              </p:sp>
              <p:sp>
                <p:nvSpPr>
                  <p:cNvPr id="30" name="Elipse 29">
                    <a:extLst>
                      <a:ext uri="{FF2B5EF4-FFF2-40B4-BE49-F238E27FC236}">
                        <a16:creationId xmlns:a16="http://schemas.microsoft.com/office/drawing/2014/main" xmlns="" id="{252E6CE1-1D20-C829-8CFA-51CBB19C77D0}"/>
                      </a:ext>
                    </a:extLst>
                  </p:cNvPr>
                  <p:cNvSpPr/>
                  <p:nvPr/>
                </p:nvSpPr>
                <p:spPr>
                  <a:xfrm>
                    <a:off x="6265329" y="3483729"/>
                    <a:ext cx="331008" cy="340509"/>
                  </a:xfrm>
                  <a:prstGeom prst="ellipse">
                    <a:avLst/>
                  </a:prstGeom>
                  <a:solidFill>
                    <a:schemeClr val="accent4">
                      <a:lumMod val="40000"/>
                      <a:lumOff val="60000"/>
                    </a:schemeClr>
                  </a:solidFill>
                  <a:ln>
                    <a:solidFill>
                      <a:schemeClr val="accent4">
                        <a:lumMod val="40000"/>
                        <a:lumOff val="60000"/>
                      </a:schemeClr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321"/>
                  </a:p>
                </p:txBody>
              </p:sp>
              <p:sp>
                <p:nvSpPr>
                  <p:cNvPr id="31" name="Elipse 30">
                    <a:extLst>
                      <a:ext uri="{FF2B5EF4-FFF2-40B4-BE49-F238E27FC236}">
                        <a16:creationId xmlns:a16="http://schemas.microsoft.com/office/drawing/2014/main" xmlns="" id="{4E29A842-8F62-A19A-255F-32B5521ED7C2}"/>
                      </a:ext>
                    </a:extLst>
                  </p:cNvPr>
                  <p:cNvSpPr/>
                  <p:nvPr/>
                </p:nvSpPr>
                <p:spPr>
                  <a:xfrm rot="1838764">
                    <a:off x="6457994" y="3541587"/>
                    <a:ext cx="23114" cy="31994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321"/>
                  </a:p>
                </p:txBody>
              </p:sp>
              <p:cxnSp>
                <p:nvCxnSpPr>
                  <p:cNvPr id="32" name="Conector recto 31">
                    <a:extLst>
                      <a:ext uri="{FF2B5EF4-FFF2-40B4-BE49-F238E27FC236}">
                        <a16:creationId xmlns:a16="http://schemas.microsoft.com/office/drawing/2014/main" xmlns="" id="{136D7F9B-A490-71B0-91B9-E7FB19A59D5F}"/>
                      </a:ext>
                    </a:extLst>
                  </p:cNvPr>
                  <p:cNvCxnSpPr>
                    <a:stCxn id="31" idx="0"/>
                  </p:cNvCxnSpPr>
                  <p:nvPr/>
                </p:nvCxnSpPr>
                <p:spPr>
                  <a:xfrm flipV="1">
                    <a:off x="6477386" y="3382706"/>
                    <a:ext cx="142153" cy="16111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4">
                    <p14:nvContentPartPr>
                      <p14:cNvPr id="33" name="Entrada de lápiz 32">
                        <a:extLst>
                          <a:ext uri="{FF2B5EF4-FFF2-40B4-BE49-F238E27FC236}">
                            <a16:creationId xmlns:a16="http://schemas.microsoft.com/office/drawing/2014/main" xmlns="" id="{D843EA2B-1545-E529-BD07-0898113A7F61}"/>
                          </a:ext>
                        </a:extLst>
                      </p14:cNvPr>
                      <p14:cNvContentPartPr/>
                      <p14:nvPr/>
                    </p14:nvContentPartPr>
                    <p14:xfrm rot="17137311">
                      <a:off x="6204752" y="3607469"/>
                      <a:ext cx="281488" cy="92670"/>
                    </p14:xfrm>
                  </p:contentPart>
                </mc:Choice>
                <mc:Fallback xmlns="">
                  <p:pic>
                    <p:nvPicPr>
                      <p:cNvPr id="128" name="Entrada de lápiz 127">
                        <a:extLst>
                          <a:ext uri="{FF2B5EF4-FFF2-40B4-BE49-F238E27FC236}">
                            <a16:creationId xmlns:a16="http://schemas.microsoft.com/office/drawing/2014/main" id="{25A9FAEA-B7B5-3EC7-0401-FAB31AB39F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 rot="17137311">
                        <a:off x="6203625" y="3606302"/>
                        <a:ext cx="283741" cy="95004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mc:AlternateContent xmlns:mc="http://schemas.openxmlformats.org/markup-compatibility/2006" xmlns:p14="http://schemas.microsoft.com/office/powerpoint/2010/main">
                <mc:Choice Requires="p14">
                  <p:contentPart p14:bwMode="auto" r:id="rId7">
                    <p14:nvContentPartPr>
                      <p14:cNvPr id="34" name="Entrada de lápiz 33">
                        <a:extLst>
                          <a:ext uri="{FF2B5EF4-FFF2-40B4-BE49-F238E27FC236}">
                            <a16:creationId xmlns:a16="http://schemas.microsoft.com/office/drawing/2014/main" xmlns="" id="{5BA348D0-F7B7-CE86-0F63-88CAEF82101F}"/>
                          </a:ext>
                        </a:extLst>
                      </p14:cNvPr>
                      <p14:cNvContentPartPr/>
                      <p14:nvPr/>
                    </p14:nvContentPartPr>
                    <p14:xfrm>
                      <a:off x="6334499" y="3569946"/>
                      <a:ext cx="196602" cy="180200"/>
                    </p14:xfrm>
                  </p:contentPart>
                </mc:Choice>
                <mc:Fallback xmlns="">
                  <p:pic>
                    <p:nvPicPr>
                      <p:cNvPr id="140" name="Entrada de lápiz 139">
                        <a:extLst>
                          <a:ext uri="{FF2B5EF4-FFF2-40B4-BE49-F238E27FC236}">
                            <a16:creationId xmlns:a16="http://schemas.microsoft.com/office/drawing/2014/main" id="{CAE838E3-2AFB-9BD8-AEAD-536B9CF012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33331" y="3568820"/>
                        <a:ext cx="198938" cy="182453"/>
                      </a:xfrm>
                      <a:prstGeom prst="rect">
                        <a:avLst/>
                      </a:prstGeom>
                    </p:spPr>
                  </p:pic>
                </mc:Fallback>
              </mc:AlternateContent>
              <p:sp>
                <p:nvSpPr>
                  <p:cNvPr id="35" name="Elipse 34">
                    <a:extLst>
                      <a:ext uri="{FF2B5EF4-FFF2-40B4-BE49-F238E27FC236}">
                        <a16:creationId xmlns:a16="http://schemas.microsoft.com/office/drawing/2014/main" xmlns="" id="{3B2964FE-9CA1-B1FB-B1E2-4569AF5169E1}"/>
                      </a:ext>
                    </a:extLst>
                  </p:cNvPr>
                  <p:cNvSpPr/>
                  <p:nvPr/>
                </p:nvSpPr>
                <p:spPr>
                  <a:xfrm rot="11016783">
                    <a:off x="7049098" y="3856428"/>
                    <a:ext cx="343046" cy="360178"/>
                  </a:xfrm>
                  <a:prstGeom prst="ellipse">
                    <a:avLst/>
                  </a:prstGeom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321"/>
                  </a:p>
                </p:txBody>
              </p:sp>
              <p:sp>
                <p:nvSpPr>
                  <p:cNvPr id="36" name="Elipse 35">
                    <a:extLst>
                      <a:ext uri="{FF2B5EF4-FFF2-40B4-BE49-F238E27FC236}">
                        <a16:creationId xmlns:a16="http://schemas.microsoft.com/office/drawing/2014/main" xmlns="" id="{A009CED6-E19A-574C-C5F0-A027B6D8CF0A}"/>
                      </a:ext>
                    </a:extLst>
                  </p:cNvPr>
                  <p:cNvSpPr/>
                  <p:nvPr/>
                </p:nvSpPr>
                <p:spPr>
                  <a:xfrm rot="11016783">
                    <a:off x="7064943" y="3870876"/>
                    <a:ext cx="312520" cy="331287"/>
                  </a:xfrm>
                  <a:prstGeom prst="ellipse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</p:spPr>
                <p:style>
                  <a:lnRef idx="2">
                    <a:schemeClr val="accent6"/>
                  </a:lnRef>
                  <a:fillRef idx="1">
                    <a:schemeClr val="lt1"/>
                  </a:fillRef>
                  <a:effectRef idx="0">
                    <a:schemeClr val="accent6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321" dirty="0"/>
                  </a:p>
                </p:txBody>
              </p:sp>
            </p:grpSp>
            <p:sp>
              <p:nvSpPr>
                <p:cNvPr id="23" name="Elipse 22">
                  <a:extLst>
                    <a:ext uri="{FF2B5EF4-FFF2-40B4-BE49-F238E27FC236}">
                      <a16:creationId xmlns:a16="http://schemas.microsoft.com/office/drawing/2014/main" xmlns="" id="{DBBEDD68-9D33-9001-FF3C-88D3F8148276}"/>
                    </a:ext>
                  </a:extLst>
                </p:cNvPr>
                <p:cNvSpPr/>
                <p:nvPr/>
              </p:nvSpPr>
              <p:spPr>
                <a:xfrm>
                  <a:off x="9750904" y="4273692"/>
                  <a:ext cx="294517" cy="326156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321"/>
                </a:p>
              </p:txBody>
            </p:sp>
            <p:sp>
              <p:nvSpPr>
                <p:cNvPr id="24" name="CuadroTexto 23">
                  <a:extLst>
                    <a:ext uri="{FF2B5EF4-FFF2-40B4-BE49-F238E27FC236}">
                      <a16:creationId xmlns:a16="http://schemas.microsoft.com/office/drawing/2014/main" xmlns="" id="{AB787F13-108B-8FF0-392A-C53E105F5566}"/>
                    </a:ext>
                  </a:extLst>
                </p:cNvPr>
                <p:cNvSpPr txBox="1"/>
                <p:nvPr/>
              </p:nvSpPr>
              <p:spPr>
                <a:xfrm>
                  <a:off x="9608317" y="4607140"/>
                  <a:ext cx="821308" cy="3181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63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hage X</a:t>
                  </a:r>
                </a:p>
              </p:txBody>
            </p:sp>
            <p:sp>
              <p:nvSpPr>
                <p:cNvPr id="25" name="CuadroTexto 24">
                  <a:extLst>
                    <a:ext uri="{FF2B5EF4-FFF2-40B4-BE49-F238E27FC236}">
                      <a16:creationId xmlns:a16="http://schemas.microsoft.com/office/drawing/2014/main" xmlns="" id="{15C3A623-F16D-03CC-F316-E2AA8C73FC37}"/>
                    </a:ext>
                  </a:extLst>
                </p:cNvPr>
                <p:cNvSpPr txBox="1"/>
                <p:nvPr/>
              </p:nvSpPr>
              <p:spPr>
                <a:xfrm>
                  <a:off x="10062851" y="4027470"/>
                  <a:ext cx="821308" cy="3181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563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hage Y</a:t>
                  </a:r>
                </a:p>
              </p:txBody>
            </p:sp>
            <p:pic>
              <p:nvPicPr>
                <p:cNvPr id="26" name="Imagen 25">
                  <a:extLst>
                    <a:ext uri="{FF2B5EF4-FFF2-40B4-BE49-F238E27FC236}">
                      <a16:creationId xmlns:a16="http://schemas.microsoft.com/office/drawing/2014/main" xmlns="" id="{6AE3F2FC-4056-0480-CC61-D3F3CDC7832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8967232" y="1030160"/>
                  <a:ext cx="2626127" cy="1782700"/>
                </a:xfrm>
                <a:prstGeom prst="rect">
                  <a:avLst/>
                </a:prstGeom>
              </p:spPr>
            </p:pic>
          </p:grpSp>
          <p:grpSp>
            <p:nvGrpSpPr>
              <p:cNvPr id="17" name="Grupo 16">
                <a:extLst>
                  <a:ext uri="{FF2B5EF4-FFF2-40B4-BE49-F238E27FC236}">
                    <a16:creationId xmlns:a16="http://schemas.microsoft.com/office/drawing/2014/main" xmlns="" id="{36B9C409-6B62-469C-DD48-0648AE72B267}"/>
                  </a:ext>
                </a:extLst>
              </p:cNvPr>
              <p:cNvGrpSpPr/>
              <p:nvPr/>
            </p:nvGrpSpPr>
            <p:grpSpPr>
              <a:xfrm>
                <a:off x="2929631" y="2317890"/>
                <a:ext cx="5942580" cy="1382281"/>
                <a:chOff x="2929631" y="2317890"/>
                <a:chExt cx="5942580" cy="1382281"/>
              </a:xfrm>
            </p:grpSpPr>
            <p:cxnSp>
              <p:nvCxnSpPr>
                <p:cNvPr id="18" name="Conector recto de flecha 17">
                  <a:extLst>
                    <a:ext uri="{FF2B5EF4-FFF2-40B4-BE49-F238E27FC236}">
                      <a16:creationId xmlns:a16="http://schemas.microsoft.com/office/drawing/2014/main" xmlns="" id="{DF0C42CC-C265-D1C3-73EE-0286CC30AC4D}"/>
                    </a:ext>
                  </a:extLst>
                </p:cNvPr>
                <p:cNvCxnSpPr/>
                <p:nvPr/>
              </p:nvCxnSpPr>
              <p:spPr>
                <a:xfrm>
                  <a:off x="5478531" y="3118556"/>
                  <a:ext cx="816746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Conector recto de flecha 18">
                  <a:extLst>
                    <a:ext uri="{FF2B5EF4-FFF2-40B4-BE49-F238E27FC236}">
                      <a16:creationId xmlns:a16="http://schemas.microsoft.com/office/drawing/2014/main" xmlns="" id="{F1B49F79-440C-F38B-83ED-FAACC95733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125556" y="2317890"/>
                  <a:ext cx="746655" cy="651924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Conector recto de flecha 19">
                  <a:extLst>
                    <a:ext uri="{FF2B5EF4-FFF2-40B4-BE49-F238E27FC236}">
                      <a16:creationId xmlns:a16="http://schemas.microsoft.com/office/drawing/2014/main" xmlns="" id="{AB16F46D-D006-2EF5-C41E-264F37DF2D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35218" y="2964664"/>
                  <a:ext cx="676422" cy="735507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Conector recto de flecha 20">
                  <a:extLst>
                    <a:ext uri="{FF2B5EF4-FFF2-40B4-BE49-F238E27FC236}">
                      <a16:creationId xmlns:a16="http://schemas.microsoft.com/office/drawing/2014/main" xmlns="" id="{60E1D84E-5E71-E2F4-7DCD-564F9EEBBA9B}"/>
                    </a:ext>
                  </a:extLst>
                </p:cNvPr>
                <p:cNvCxnSpPr/>
                <p:nvPr/>
              </p:nvCxnSpPr>
              <p:spPr>
                <a:xfrm>
                  <a:off x="2929631" y="3118556"/>
                  <a:ext cx="816746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xmlns="" id="{073BE5A3-45B3-2C06-21E3-C128F332D531}"/>
                </a:ext>
              </a:extLst>
            </p:cNvPr>
            <p:cNvSpPr txBox="1"/>
            <p:nvPr/>
          </p:nvSpPr>
          <p:spPr>
            <a:xfrm>
              <a:off x="279095" y="5117297"/>
              <a:ext cx="518091" cy="187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Soft Agar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xmlns="" id="{DF11C44D-2E6F-3FBA-0777-F82494E58720}"/>
                </a:ext>
              </a:extLst>
            </p:cNvPr>
            <p:cNvSpPr txBox="1"/>
            <p:nvPr/>
          </p:nvSpPr>
          <p:spPr>
            <a:xfrm>
              <a:off x="1077372" y="5166569"/>
              <a:ext cx="627095" cy="187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Phage stock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71938A3F-59DD-C2CF-B907-AF7A307502B0}"/>
                </a:ext>
              </a:extLst>
            </p:cNvPr>
            <p:cNvSpPr txBox="1"/>
            <p:nvPr/>
          </p:nvSpPr>
          <p:spPr>
            <a:xfrm>
              <a:off x="1555197" y="5777114"/>
              <a:ext cx="731210" cy="178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37° C ,Overnight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xmlns="" id="{2644CBB6-DC5D-CC96-7E6A-46B5E204BBD1}"/>
                </a:ext>
              </a:extLst>
            </p:cNvPr>
            <p:cNvSpPr txBox="1"/>
            <p:nvPr/>
          </p:nvSpPr>
          <p:spPr>
            <a:xfrm>
              <a:off x="2089366" y="6382699"/>
              <a:ext cx="1051452" cy="2828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Probable phage-resistant clones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xmlns="" id="{7CE71E7C-BDDB-D155-4988-CA3F5B9EDEA0}"/>
                </a:ext>
              </a:extLst>
            </p:cNvPr>
            <p:cNvSpPr txBox="1"/>
            <p:nvPr/>
          </p:nvSpPr>
          <p:spPr>
            <a:xfrm>
              <a:off x="3551838" y="4955404"/>
              <a:ext cx="1051452" cy="2828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Isolation of probable phage-resistant clones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xmlns="" id="{6510CE66-F13F-8F29-4B52-DE1BE3D72BB8}"/>
                </a:ext>
              </a:extLst>
            </p:cNvPr>
            <p:cNvSpPr txBox="1"/>
            <p:nvPr/>
          </p:nvSpPr>
          <p:spPr>
            <a:xfrm>
              <a:off x="5236896" y="5838794"/>
              <a:ext cx="1051452" cy="2828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Assessment of phage resistance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xmlns="" id="{D96EC37B-BFD4-C0D0-7B96-1C9BE09ECEE2}"/>
                </a:ext>
              </a:extLst>
            </p:cNvPr>
            <p:cNvSpPr txBox="1"/>
            <p:nvPr/>
          </p:nvSpPr>
          <p:spPr>
            <a:xfrm>
              <a:off x="5208948" y="7102020"/>
              <a:ext cx="1186640" cy="2689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Spot test. Cross-Resistance experiments 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xmlns="" id="{24A707BD-462E-4ADF-6BAB-CDFA23A0B690}"/>
                </a:ext>
              </a:extLst>
            </p:cNvPr>
            <p:cNvSpPr txBox="1"/>
            <p:nvPr/>
          </p:nvSpPr>
          <p:spPr>
            <a:xfrm>
              <a:off x="5216493" y="4630615"/>
              <a:ext cx="1051452" cy="1876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Growth curves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xmlns="" id="{9C518F29-BC77-D055-169B-0A4345A40AD5}"/>
                </a:ext>
              </a:extLst>
            </p:cNvPr>
            <p:cNvSpPr txBox="1"/>
            <p:nvPr/>
          </p:nvSpPr>
          <p:spPr>
            <a:xfrm>
              <a:off x="566212" y="6371724"/>
              <a:ext cx="1051452" cy="1876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19" dirty="0">
                  <a:latin typeface="Arial" panose="020B0604020202020204" pitchFamily="34" charset="0"/>
                  <a:cs typeface="Arial" panose="020B0604020202020204" pitchFamily="34" charset="0"/>
                </a:rPr>
                <a:t>Spot test  </a:t>
              </a:r>
            </a:p>
          </p:txBody>
        </p:sp>
      </p:grpSp>
      <p:graphicFrame>
        <p:nvGraphicFramePr>
          <p:cNvPr id="52" name="Objeto 51">
            <a:extLst>
              <a:ext uri="{FF2B5EF4-FFF2-40B4-BE49-F238E27FC236}">
                <a16:creationId xmlns:a16="http://schemas.microsoft.com/office/drawing/2014/main" xmlns="" id="{B46B2F3F-9F23-C403-15BC-DCF1043E7F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5320277"/>
              </p:ext>
            </p:extLst>
          </p:nvPr>
        </p:nvGraphicFramePr>
        <p:xfrm>
          <a:off x="110783" y="6065389"/>
          <a:ext cx="3288056" cy="1525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10" imgW="5955084" imgH="2709431" progId="Prism8.Document">
                  <p:embed/>
                </p:oleObj>
              </mc:Choice>
              <mc:Fallback>
                <p:oleObj name="Prism 8" r:id="rId10" imgW="5955084" imgH="2709431" progId="Prism8.Document">
                  <p:embed/>
                  <p:pic>
                    <p:nvPicPr>
                      <p:cNvPr id="52" name="Objeto 51">
                        <a:extLst>
                          <a:ext uri="{FF2B5EF4-FFF2-40B4-BE49-F238E27FC236}">
                            <a16:creationId xmlns:a16="http://schemas.microsoft.com/office/drawing/2014/main" xmlns="" id="{B46B2F3F-9F23-C403-15BC-DCF1043E7F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10783" y="6065389"/>
                        <a:ext cx="3288056" cy="1525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to 52">
            <a:extLst>
              <a:ext uri="{FF2B5EF4-FFF2-40B4-BE49-F238E27FC236}">
                <a16:creationId xmlns:a16="http://schemas.microsoft.com/office/drawing/2014/main" xmlns="" id="{9FA7C436-ECC4-5E0A-C016-D6775C5BD7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6308045"/>
              </p:ext>
            </p:extLst>
          </p:nvPr>
        </p:nvGraphicFramePr>
        <p:xfrm>
          <a:off x="143171" y="7784845"/>
          <a:ext cx="3344862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12" imgW="5948964" imgH="2709431" progId="Prism8.Document">
                  <p:embed/>
                </p:oleObj>
              </mc:Choice>
              <mc:Fallback>
                <p:oleObj name="Prism 8" r:id="rId12" imgW="5948964" imgH="2709431" progId="Prism8.Document">
                  <p:embed/>
                  <p:pic>
                    <p:nvPicPr>
                      <p:cNvPr id="53" name="Objeto 52">
                        <a:extLst>
                          <a:ext uri="{FF2B5EF4-FFF2-40B4-BE49-F238E27FC236}">
                            <a16:creationId xmlns:a16="http://schemas.microsoft.com/office/drawing/2014/main" xmlns="" id="{9FA7C436-ECC4-5E0A-C016-D6775C5BD7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43171" y="7784845"/>
                        <a:ext cx="3344862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to 53">
            <a:extLst>
              <a:ext uri="{FF2B5EF4-FFF2-40B4-BE49-F238E27FC236}">
                <a16:creationId xmlns:a16="http://schemas.microsoft.com/office/drawing/2014/main" xmlns="" id="{0DEFCC98-C9CB-B85F-2F72-C68B135FBA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1689403"/>
              </p:ext>
            </p:extLst>
          </p:nvPr>
        </p:nvGraphicFramePr>
        <p:xfrm>
          <a:off x="3449638" y="7802563"/>
          <a:ext cx="3363912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8" r:id="rId14" imgW="5977761" imgH="2709431" progId="Prism8.Document">
                  <p:embed/>
                </p:oleObj>
              </mc:Choice>
              <mc:Fallback>
                <p:oleObj name="Prism 8" r:id="rId14" imgW="5977761" imgH="2709431" progId="Prism8.Document">
                  <p:embed/>
                  <p:pic>
                    <p:nvPicPr>
                      <p:cNvPr id="54" name="Objeto 53">
                        <a:extLst>
                          <a:ext uri="{FF2B5EF4-FFF2-40B4-BE49-F238E27FC236}">
                            <a16:creationId xmlns:a16="http://schemas.microsoft.com/office/drawing/2014/main" xmlns="" id="{0DEFCC98-C9CB-B85F-2F72-C68B135FBA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449638" y="7802563"/>
                        <a:ext cx="3363912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to 54">
            <a:extLst>
              <a:ext uri="{FF2B5EF4-FFF2-40B4-BE49-F238E27FC236}">
                <a16:creationId xmlns:a16="http://schemas.microsoft.com/office/drawing/2014/main" xmlns="" id="{3E887292-2142-5BC2-491E-F727E05353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7435014"/>
              </p:ext>
            </p:extLst>
          </p:nvPr>
        </p:nvGraphicFramePr>
        <p:xfrm>
          <a:off x="3436658" y="6085139"/>
          <a:ext cx="3311525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8" r:id="rId16" imgW="5888132" imgH="2709431" progId="Prism8.Document">
                  <p:embed/>
                </p:oleObj>
              </mc:Choice>
              <mc:Fallback>
                <p:oleObj name="Prism 8" r:id="rId16" imgW="5888132" imgH="2709431" progId="Prism8.Document">
                  <p:embed/>
                  <p:pic>
                    <p:nvPicPr>
                      <p:cNvPr id="55" name="Objeto 54">
                        <a:extLst>
                          <a:ext uri="{FF2B5EF4-FFF2-40B4-BE49-F238E27FC236}">
                            <a16:creationId xmlns:a16="http://schemas.microsoft.com/office/drawing/2014/main" xmlns="" id="{3E887292-2142-5BC2-491E-F727E05353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436658" y="6085139"/>
                        <a:ext cx="3311525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to 55">
            <a:extLst>
              <a:ext uri="{FF2B5EF4-FFF2-40B4-BE49-F238E27FC236}">
                <a16:creationId xmlns:a16="http://schemas.microsoft.com/office/drawing/2014/main" xmlns="" id="{26EBABC5-0527-0D2A-FF23-C692A73A6DF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43171" y="4316815"/>
          <a:ext cx="3317236" cy="16249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8" r:id="rId18" imgW="6287322" imgH="2709431" progId="Prism8.Document">
                  <p:embed/>
                </p:oleObj>
              </mc:Choice>
              <mc:Fallback>
                <p:oleObj name="Prism 8" r:id="rId18" imgW="6287322" imgH="2709431" progId="Prism8.Document">
                  <p:embed/>
                  <p:pic>
                    <p:nvPicPr>
                      <p:cNvPr id="56" name="Objeto 55">
                        <a:extLst>
                          <a:ext uri="{FF2B5EF4-FFF2-40B4-BE49-F238E27FC236}">
                            <a16:creationId xmlns:a16="http://schemas.microsoft.com/office/drawing/2014/main" xmlns="" id="{26EBABC5-0527-0D2A-FF23-C692A73A6D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43171" y="4316815"/>
                        <a:ext cx="3317236" cy="16249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to 56">
            <a:extLst>
              <a:ext uri="{FF2B5EF4-FFF2-40B4-BE49-F238E27FC236}">
                <a16:creationId xmlns:a16="http://schemas.microsoft.com/office/drawing/2014/main" xmlns="" id="{84BA3DA3-1C36-3807-8F13-D6674C4F03E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60407" y="4367270"/>
          <a:ext cx="3349625" cy="15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8" r:id="rId20" imgW="6470178" imgH="2709431" progId="Prism8.Document">
                  <p:embed/>
                </p:oleObj>
              </mc:Choice>
              <mc:Fallback>
                <p:oleObj name="Prism 8" r:id="rId20" imgW="6470178" imgH="2709431" progId="Prism8.Document">
                  <p:embed/>
                  <p:pic>
                    <p:nvPicPr>
                      <p:cNvPr id="57" name="Objeto 56">
                        <a:extLst>
                          <a:ext uri="{FF2B5EF4-FFF2-40B4-BE49-F238E27FC236}">
                            <a16:creationId xmlns:a16="http://schemas.microsoft.com/office/drawing/2014/main" xmlns="" id="{84BA3DA3-1C36-3807-8F13-D6674C4F03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460407" y="4367270"/>
                        <a:ext cx="3349625" cy="15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CuadroTexto 2">
            <a:extLst>
              <a:ext uri="{FF2B5EF4-FFF2-40B4-BE49-F238E27FC236}">
                <a16:creationId xmlns:a16="http://schemas.microsoft.com/office/drawing/2014/main" xmlns="" id="{2BD0F0A3-FBF0-3A69-6E9A-DFFAEB41DF12}"/>
              </a:ext>
            </a:extLst>
          </p:cNvPr>
          <p:cNvSpPr txBox="1"/>
          <p:nvPr/>
        </p:nvSpPr>
        <p:spPr>
          <a:xfrm>
            <a:off x="518367" y="1165863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xmlns="" id="{BDCC1687-25D5-7812-CB9F-01400F1E4480}"/>
              </a:ext>
            </a:extLst>
          </p:cNvPr>
          <p:cNvSpPr txBox="1"/>
          <p:nvPr/>
        </p:nvSpPr>
        <p:spPr>
          <a:xfrm>
            <a:off x="242256" y="4027116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xmlns="" id="{29C41F12-233E-39B0-FFC0-26DDB8F1E1FE}"/>
              </a:ext>
            </a:extLst>
          </p:cNvPr>
          <p:cNvSpPr txBox="1"/>
          <p:nvPr/>
        </p:nvSpPr>
        <p:spPr>
          <a:xfrm>
            <a:off x="3576037" y="4026886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xmlns="" id="{29111BF8-DBC7-C4CF-42DE-FAB1BBBF1096}"/>
              </a:ext>
            </a:extLst>
          </p:cNvPr>
          <p:cNvSpPr txBox="1"/>
          <p:nvPr/>
        </p:nvSpPr>
        <p:spPr>
          <a:xfrm>
            <a:off x="242256" y="5899668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xmlns="" id="{6AA4A439-278E-6B55-DE55-F1256290B742}"/>
              </a:ext>
            </a:extLst>
          </p:cNvPr>
          <p:cNvSpPr txBox="1"/>
          <p:nvPr/>
        </p:nvSpPr>
        <p:spPr>
          <a:xfrm>
            <a:off x="3576037" y="5909433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xmlns="" id="{99C07983-B8B0-86F8-F91F-88F6ADFFB11C}"/>
              </a:ext>
            </a:extLst>
          </p:cNvPr>
          <p:cNvSpPr txBox="1"/>
          <p:nvPr/>
        </p:nvSpPr>
        <p:spPr>
          <a:xfrm>
            <a:off x="244481" y="7586131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xmlns="" id="{939FF967-86F5-BADB-BDB0-4E87B25098C4}"/>
              </a:ext>
            </a:extLst>
          </p:cNvPr>
          <p:cNvSpPr txBox="1"/>
          <p:nvPr/>
        </p:nvSpPr>
        <p:spPr>
          <a:xfrm>
            <a:off x="3552192" y="7590266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xmlns="" id="{F6AD1868-CAB2-36A7-090C-4F2812AFFE5E}"/>
              </a:ext>
            </a:extLst>
          </p:cNvPr>
          <p:cNvSpPr txBox="1"/>
          <p:nvPr/>
        </p:nvSpPr>
        <p:spPr>
          <a:xfrm>
            <a:off x="668746" y="9473295"/>
            <a:ext cx="5764048" cy="10275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13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A)  Graphical representation of the methodology used to isolate and verify the resistance of the phage-resistant clones. </a:t>
            </a:r>
          </a:p>
          <a:p>
            <a:pPr algn="just"/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Growth curves of the </a:t>
            </a:r>
            <a:r>
              <a:rPr lang="en-US" sz="1013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PA14,</a:t>
            </a:r>
            <a:r>
              <a:rPr lang="en-US" sz="1013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RME-58 and RME-75 resistant clones to phage 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 φ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DCL-PA6 (B, D and F) and to phage 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(C, E and G). </a:t>
            </a:r>
            <a:endParaRPr 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013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PA14 resistant clones to phage 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(C) are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less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sensitive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phage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13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PA14 WT,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but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they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remain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13" dirty="0">
                <a:latin typeface="Arial" panose="020B0604020202020204" pitchFamily="34" charset="0"/>
                <a:cs typeface="Arial" panose="020B0604020202020204" pitchFamily="34" charset="0"/>
              </a:rPr>
              <a:t>infected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13" dirty="0" err="1">
                <a:latin typeface="Arial" panose="020B0604020202020204" pitchFamily="34" charset="0"/>
                <a:cs typeface="Arial" panose="020B0604020202020204" pitchFamily="34" charset="0"/>
              </a:rPr>
              <a:t>phage</a:t>
            </a:r>
            <a:r>
              <a:rPr lang="es-MX" sz="1013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ítulo 1">
            <a:extLst>
              <a:ext uri="{FF2B5EF4-FFF2-40B4-BE49-F238E27FC236}">
                <a16:creationId xmlns:a16="http://schemas.microsoft.com/office/drawing/2014/main" xmlns="" id="{45C72E12-48AD-8E8C-FFB9-B1B2086E60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97087" y="-34564"/>
            <a:ext cx="5915025" cy="647841"/>
          </a:xfrm>
        </p:spPr>
        <p:txBody>
          <a:bodyPr>
            <a:normAutofit/>
          </a:bodyPr>
          <a:lstStyle/>
          <a:p>
            <a:r>
              <a:rPr lang="en-US" sz="2000" b="1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1280866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xmlns="" id="{93C33AC5-9B21-6C21-CDA1-713D4E8BE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376" y="3410921"/>
            <a:ext cx="6669248" cy="783574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xmlns="" id="{ED093D2C-1F68-2D08-4534-5D670EDA00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8185" y="4909562"/>
            <a:ext cx="3803938" cy="1186438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xmlns="" id="{3E676F8A-2296-50F0-17DF-0C590BB33AE3}"/>
              </a:ext>
            </a:extLst>
          </p:cNvPr>
          <p:cNvSpPr txBox="1"/>
          <p:nvPr/>
        </p:nvSpPr>
        <p:spPr>
          <a:xfrm>
            <a:off x="345149" y="3017096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xmlns="" id="{4D6FB5AD-8A69-B917-D917-9A2053D344BF}"/>
              </a:ext>
            </a:extLst>
          </p:cNvPr>
          <p:cNvSpPr txBox="1"/>
          <p:nvPr/>
        </p:nvSpPr>
        <p:spPr>
          <a:xfrm>
            <a:off x="1061825" y="4570458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xmlns="" id="{30931428-B8C0-2540-40A5-A2813B1532A0}"/>
              </a:ext>
            </a:extLst>
          </p:cNvPr>
          <p:cNvSpPr txBox="1"/>
          <p:nvPr/>
        </p:nvSpPr>
        <p:spPr>
          <a:xfrm>
            <a:off x="573552" y="6479439"/>
            <a:ext cx="5896917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A) Host Range of phages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, its variant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JBD30 (a known phage that employs type IV pilus as receptor) against a set of clinical isolates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DR strains and the reference strains PAO1 and PA14. S= sensitive; R= Resistant.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) Phage Cross-resistance of phages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,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JBD30 against the phage-resistant clones to phag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 (14R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) and to phag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14R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The three phages can infect the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14 WT. JBD30 phage infects the PA14 resistant clones to phag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 and its variant, suggesting that the receptor of those phages is different from the type IV pilus. Phag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nable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infect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resistant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clones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phage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suggesting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receptor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them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however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s-MX" sz="1000" dirty="0" err="1">
                <a:latin typeface="Arial" panose="020B0604020202020204" pitchFamily="34" charset="0"/>
                <a:cs typeface="Arial" panose="020B0604020202020204" pitchFamily="34" charset="0"/>
              </a:rPr>
              <a:t>phage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an infect the resistant clones to phage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, suggesting that the receptor of phages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 and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may be on the same structure but in different location.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000" dirty="0"/>
          </a:p>
        </p:txBody>
      </p:sp>
      <p:sp>
        <p:nvSpPr>
          <p:cNvPr id="6" name="5 CuadroTexto">
            <a:extLst>
              <a:ext uri="{FF2B5EF4-FFF2-40B4-BE49-F238E27FC236}">
                <a16:creationId xmlns:a16="http://schemas.microsoft.com/office/drawing/2014/main" xmlns="" id="{2714E7E2-A999-D704-D7FC-2935AEB31293}"/>
              </a:ext>
            </a:extLst>
          </p:cNvPr>
          <p:cNvSpPr txBox="1"/>
          <p:nvPr/>
        </p:nvSpPr>
        <p:spPr>
          <a:xfrm>
            <a:off x="345149" y="329609"/>
            <a:ext cx="5906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41645824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xmlns="" id="{0BD0BAC0-0394-5B14-41E3-54B88C820F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1393653"/>
              </p:ext>
            </p:extLst>
          </p:nvPr>
        </p:nvGraphicFramePr>
        <p:xfrm>
          <a:off x="235980" y="1005731"/>
          <a:ext cx="3193020" cy="733744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972528">
                  <a:extLst>
                    <a:ext uri="{9D8B030D-6E8A-4147-A177-3AD203B41FA5}">
                      <a16:colId xmlns:a16="http://schemas.microsoft.com/office/drawing/2014/main" xmlns="" val="1254789989"/>
                    </a:ext>
                  </a:extLst>
                </a:gridCol>
                <a:gridCol w="1220492">
                  <a:extLst>
                    <a:ext uri="{9D8B030D-6E8A-4147-A177-3AD203B41FA5}">
                      <a16:colId xmlns:a16="http://schemas.microsoft.com/office/drawing/2014/main" xmlns="" val="953733114"/>
                    </a:ext>
                  </a:extLst>
                </a:gridCol>
              </a:tblGrid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 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95140279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termination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s-MX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09..1244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661511353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plat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x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92..29185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508701838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plat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zation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179..28583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700187086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plate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627..37141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015564265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plate stabilizing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28..26751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589104183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plate wedge subunit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748..27098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54021673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plat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dg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unit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377..35631</a:t>
                      </a:r>
                    </a:p>
                  </a:txBody>
                  <a:tcPr marL="35275" marR="35275" marT="0" marB="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85595830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stein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oxygenas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20..11407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25004739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iting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ofreading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nuclease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629..51183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82860119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helic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563..47122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35088851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lig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681..42592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331441366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polymer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522..50632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932215976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prim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026..63756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63688836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A prim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611..61688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123893618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lys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64..41126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961391431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odeoxyribonucle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765..57952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93076786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d completion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388..22855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886047508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d completion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852..2325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010284838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d maturation prote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604..20037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52918924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d morphogenesis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92..17728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4508302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t-nuclease inhibitor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848..45480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71749418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rge terminase subunit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88..8070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9849085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jor Head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611..61687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32798123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or head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95..16892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897285006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cle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119..47529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06917194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ynucleotide kin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259..52278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117705880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ncturing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03..33066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933774322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ophosphat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647..43201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28967945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terminase subunit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729..65301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452012458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uble lytic murein transglycosyl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627..32203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61776843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uctural virion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41..20676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580663269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assambly chaperon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868..54086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788305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completion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863..24387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067441861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fiber assembly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36..40464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872018043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fiber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146..40034</a:t>
                      </a:r>
                    </a:p>
                  </a:txBody>
                  <a:tcPr marL="35275" marR="35275" marT="0" marB="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29449186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lenght tape measure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14..6000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15534309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sheath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403..25917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255427747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terminator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58..23809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975809801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tube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976..26428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064725450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tube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541..28044</a:t>
                      </a:r>
                    </a:p>
                  </a:txBody>
                  <a:tcPr marL="35275" marR="35275" marT="0" marB="0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58020615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midylate synth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474..53391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703298380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cription initiation factor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713..56603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22881466"/>
                  </a:ext>
                </a:extLst>
              </a:tr>
              <a:tr h="8622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P-galactopyranose mutase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607..55608</a:t>
                      </a: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137214009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9..1198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19490426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8..1525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628117254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3..1794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577607364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04..203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844002588"/>
                  </a:ext>
                </a:extLst>
              </a:tr>
              <a:tr h="7963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5..2309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053710261"/>
                  </a:ext>
                </a:extLst>
              </a:tr>
            </a:tbl>
          </a:graphicData>
        </a:graphic>
      </p:graphicFrame>
      <p:graphicFrame>
        <p:nvGraphicFramePr>
          <p:cNvPr id="5" name="Tabla 4">
            <a:extLst>
              <a:ext uri="{FF2B5EF4-FFF2-40B4-BE49-F238E27FC236}">
                <a16:creationId xmlns:a16="http://schemas.microsoft.com/office/drawing/2014/main" xmlns="" id="{5651C8B8-CF08-7818-6E2E-FC6A1FB45F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8450567"/>
              </p:ext>
            </p:extLst>
          </p:nvPr>
        </p:nvGraphicFramePr>
        <p:xfrm>
          <a:off x="3429000" y="1005730"/>
          <a:ext cx="3193020" cy="6750454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832675">
                  <a:extLst>
                    <a:ext uri="{9D8B030D-6E8A-4147-A177-3AD203B41FA5}">
                      <a16:colId xmlns:a16="http://schemas.microsoft.com/office/drawing/2014/main" xmlns="" val="2104882077"/>
                    </a:ext>
                  </a:extLst>
                </a:gridCol>
                <a:gridCol w="1360345">
                  <a:extLst>
                    <a:ext uri="{9D8B030D-6E8A-4147-A177-3AD203B41FA5}">
                      <a16:colId xmlns:a16="http://schemas.microsoft.com/office/drawing/2014/main" xmlns="" val="2644710781"/>
                    </a:ext>
                  </a:extLst>
                </a:gridCol>
              </a:tblGrid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 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22755423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75..2701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82754569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2..3346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913651208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78..3590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507647708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7..3787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023924056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4..3999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896510731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96..4196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487413800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3..4444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23890929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56..4768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302945787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12..5042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76268483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23..531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812859191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66..6512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077267890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07..8490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68564549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90..8705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945231896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05..9055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233146356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99..9497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4178476710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00..10279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958673458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66..10803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949272771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45..12892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971324051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141..13686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39353479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58..1398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137965815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13..14414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7015998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47..17953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098304395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50..18090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444257420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92..2191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01022273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36..22373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325954700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00..27531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263618288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195..29623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771150979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066..33599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231993306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150..41401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804284254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198..43803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44340757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860..44759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881099250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281..52472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521880974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031..53237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44386836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605..53835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66018891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070..54288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246492334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288..54518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69151431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939..58361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396812997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530..59315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637264115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578..60165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986841722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165..60614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842475793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693..61878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1334397885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956..64537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3531216325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468..310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340084073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</a:t>
                      </a: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MX" sz="900" kern="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..452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05325574"/>
                  </a:ext>
                </a:extLst>
              </a:tr>
              <a:tr h="13749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tical protein</a:t>
                      </a:r>
                      <a:endParaRPr lang="es-MX" sz="900" kern="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2293620" algn="l"/>
                        </a:tabLst>
                      </a:pPr>
                      <a:r>
                        <a:rPr lang="es-MX" sz="9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9..813</a:t>
                      </a:r>
                      <a:endParaRPr lang="es-MX" sz="900" kern="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5275" marR="35275" marT="0" marB="0"/>
                </a:tc>
                <a:extLst>
                  <a:ext uri="{0D108BD9-81ED-4DB2-BD59-A6C34878D82A}">
                    <a16:rowId xmlns:a16="http://schemas.microsoft.com/office/drawing/2014/main" xmlns="" val="2359634924"/>
                  </a:ext>
                </a:extLst>
              </a:tr>
            </a:tbl>
          </a:graphicData>
        </a:graphic>
      </p:graphicFrame>
      <p:sp>
        <p:nvSpPr>
          <p:cNvPr id="10" name="5 CuadroTexto">
            <a:extLst>
              <a:ext uri="{FF2B5EF4-FFF2-40B4-BE49-F238E27FC236}">
                <a16:creationId xmlns:a16="http://schemas.microsoft.com/office/drawing/2014/main" xmlns="" id="{9B2A54EF-B2AF-8455-21E7-2A15F641547D}"/>
              </a:ext>
            </a:extLst>
          </p:cNvPr>
          <p:cNvSpPr txBox="1"/>
          <p:nvPr/>
        </p:nvSpPr>
        <p:spPr>
          <a:xfrm>
            <a:off x="318977" y="329609"/>
            <a:ext cx="6379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5A7C4D7F-5D06-6CEF-4FCD-C7A4B9C10953}"/>
              </a:ext>
            </a:extLst>
          </p:cNvPr>
          <p:cNvSpPr txBox="1"/>
          <p:nvPr/>
        </p:nvSpPr>
        <p:spPr>
          <a:xfrm>
            <a:off x="318977" y="8665735"/>
            <a:ext cx="6041247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Genes encoded in the genome of phage φDCL-PA6. Gene positions were determined using the NCBI sequence (OR436899) as reference. The genes with mutations in the phage variant φDCL-PA6α are colored in red.</a:t>
            </a:r>
          </a:p>
        </p:txBody>
      </p:sp>
    </p:spTree>
    <p:extLst>
      <p:ext uri="{BB962C8B-B14F-4D97-AF65-F5344CB8AC3E}">
        <p14:creationId xmlns:p14="http://schemas.microsoft.com/office/powerpoint/2010/main" val="34394811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xmlns="" id="{1816E014-F003-B226-A166-EC35189314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0112212"/>
              </p:ext>
            </p:extLst>
          </p:nvPr>
        </p:nvGraphicFramePr>
        <p:xfrm>
          <a:off x="622300" y="3523746"/>
          <a:ext cx="2681288" cy="2417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8" r:id="rId3" imgW="3399768" imgH="3251893" progId="Prism8.Document">
                  <p:embed/>
                </p:oleObj>
              </mc:Choice>
              <mc:Fallback>
                <p:oleObj name="Prism 8" r:id="rId3" imgW="3399768" imgH="3251893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xmlns="" id="{1816E014-F003-B226-A166-EC35189314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22300" y="3523746"/>
                        <a:ext cx="2681288" cy="2417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xmlns="" id="{E9D0B8D4-E7A1-EA54-E4D8-F8BAA01CF5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5613353"/>
              </p:ext>
            </p:extLst>
          </p:nvPr>
        </p:nvGraphicFramePr>
        <p:xfrm>
          <a:off x="3623790" y="3517396"/>
          <a:ext cx="2517775" cy="2424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5" imgW="3440803" imgH="3312727" progId="Prism8.Document">
                  <p:embed/>
                </p:oleObj>
              </mc:Choice>
              <mc:Fallback>
                <p:oleObj name="Prism 8" r:id="rId5" imgW="3440803" imgH="3312727" progId="Prism8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xmlns="" id="{E9D0B8D4-E7A1-EA54-E4D8-F8BAA01CF5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23790" y="3517396"/>
                        <a:ext cx="2517775" cy="2424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xmlns="" id="{BDA7323B-1E01-D4C9-AF73-A98C9B3C85D7}"/>
              </a:ext>
            </a:extLst>
          </p:cNvPr>
          <p:cNvSpPr txBox="1"/>
          <p:nvPr/>
        </p:nvSpPr>
        <p:spPr>
          <a:xfrm>
            <a:off x="445274" y="3394285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xmlns="" id="{BF215054-F3BF-D47E-A5E3-11C1FDD80BED}"/>
              </a:ext>
            </a:extLst>
          </p:cNvPr>
          <p:cNvSpPr txBox="1"/>
          <p:nvPr/>
        </p:nvSpPr>
        <p:spPr>
          <a:xfrm>
            <a:off x="3377388" y="3376577"/>
            <a:ext cx="35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000" b="1" noProof="1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xmlns="" id="{1371D790-4698-D102-C593-7B413BDB6D34}"/>
              </a:ext>
            </a:extLst>
          </p:cNvPr>
          <p:cNvSpPr txBox="1"/>
          <p:nvPr/>
        </p:nvSpPr>
        <p:spPr>
          <a:xfrm>
            <a:off x="473066" y="6082328"/>
            <a:ext cx="5911867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Overnight pyocyanin production in LB medium (A) and caseinolytic activity (B)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. aeruginos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A14 phage-resistant clones to phages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 (14R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)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R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φ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CL-PA6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MX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bars represent the mean of three experiments. For the statistical analysis, the Kruskal-Wallis and the Dunn’s tests for independent groups were used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values &lt; 0.05 were regarded as significant compared to the PA14 WT group.</a:t>
            </a:r>
            <a:endParaRPr lang="en-US" sz="1000" dirty="0"/>
          </a:p>
        </p:txBody>
      </p:sp>
      <p:sp>
        <p:nvSpPr>
          <p:cNvPr id="5" name="4 CuadroTexto">
            <a:extLst>
              <a:ext uri="{FF2B5EF4-FFF2-40B4-BE49-F238E27FC236}">
                <a16:creationId xmlns:a16="http://schemas.microsoft.com/office/drawing/2014/main" xmlns="" id="{4F58AD2A-7270-3B12-4316-99904EAC997F}"/>
              </a:ext>
            </a:extLst>
          </p:cNvPr>
          <p:cNvSpPr txBox="1"/>
          <p:nvPr/>
        </p:nvSpPr>
        <p:spPr>
          <a:xfrm>
            <a:off x="318977" y="329609"/>
            <a:ext cx="6379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4776087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6">
            <a:extLst>
              <a:ext uri="{FF2B5EF4-FFF2-40B4-BE49-F238E27FC236}">
                <a16:creationId xmlns:a16="http://schemas.microsoft.com/office/drawing/2014/main" xmlns="" id="{4B21179D-29ED-55EE-EE05-7919F80C4989}"/>
              </a:ext>
            </a:extLst>
          </p:cNvPr>
          <p:cNvSpPr txBox="1"/>
          <p:nvPr/>
        </p:nvSpPr>
        <p:spPr>
          <a:xfrm>
            <a:off x="578843" y="6376949"/>
            <a:ext cx="5880679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Heat map of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fold changes in MIC values against a panel of 14 antibiotics. Heat map intensities for each phage-resistant clone represent the fold change in MIC compared to the wild-type RME 58 strain. S, sensitive; I, intermediate; R, resistant; FC,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fold changes. CAZ: Ceftazidime, CRO: Ceftriaxone, FEP: Cefepime, DOR: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Doripene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IPM: Imipenem, MEM: Meropenem, AMK: Amikacin, GEN: Gentamicin, CIP: Ciprofloxacin, TGC: Tigecycline, TOB: Tobramycin, ATM: Aztreonam, CST: Colistin, TZP: Tazobactam/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iperacillin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/>
          </a:p>
        </p:txBody>
      </p:sp>
      <p:sp>
        <p:nvSpPr>
          <p:cNvPr id="5" name="5 CuadroTexto">
            <a:extLst>
              <a:ext uri="{FF2B5EF4-FFF2-40B4-BE49-F238E27FC236}">
                <a16:creationId xmlns:a16="http://schemas.microsoft.com/office/drawing/2014/main" xmlns="" id="{692384EE-C57B-553A-7BB7-E0761F3E4AC4}"/>
              </a:ext>
            </a:extLst>
          </p:cNvPr>
          <p:cNvSpPr txBox="1"/>
          <p:nvPr/>
        </p:nvSpPr>
        <p:spPr>
          <a:xfrm>
            <a:off x="318977" y="329609"/>
            <a:ext cx="63795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6</a:t>
            </a:r>
          </a:p>
        </p:txBody>
      </p:sp>
      <p:grpSp>
        <p:nvGrpSpPr>
          <p:cNvPr id="6" name="Grupo 5">
            <a:extLst>
              <a:ext uri="{FF2B5EF4-FFF2-40B4-BE49-F238E27FC236}">
                <a16:creationId xmlns:a16="http://schemas.microsoft.com/office/drawing/2014/main" xmlns="" id="{8A9C3457-6A2E-2040-20BB-3EA53A73DDA3}"/>
              </a:ext>
            </a:extLst>
          </p:cNvPr>
          <p:cNvGrpSpPr/>
          <p:nvPr/>
        </p:nvGrpSpPr>
        <p:grpSpPr>
          <a:xfrm>
            <a:off x="566589" y="3573413"/>
            <a:ext cx="8254571" cy="2742146"/>
            <a:chOff x="681038" y="3472674"/>
            <a:chExt cx="7892510" cy="2489976"/>
          </a:xfrm>
        </p:grpSpPr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xmlns="" id="{CDE8FA89-EB6E-C771-FF02-57C94DB9FD0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02822660"/>
                </p:ext>
              </p:extLst>
            </p:nvPr>
          </p:nvGraphicFramePr>
          <p:xfrm>
            <a:off x="681038" y="3595688"/>
            <a:ext cx="5494337" cy="23669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4" name="Prism 8" r:id="rId3" imgW="5886332" imgH="2534130" progId="Prism8.Document">
                    <p:embed/>
                  </p:oleObj>
                </mc:Choice>
                <mc:Fallback>
                  <p:oleObj name="Prism 8" r:id="rId3" imgW="5886332" imgH="2534130" progId="Prism8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xmlns="" id="{4912F2E1-A846-4D3A-BE5E-C6A1EFBA146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81038" y="3595688"/>
                          <a:ext cx="5494337" cy="23669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xmlns="" id="{0E2EA309-69F5-7921-A1B0-30417AD2D5C3}"/>
                </a:ext>
              </a:extLst>
            </p:cNvPr>
            <p:cNvSpPr txBox="1"/>
            <p:nvPr/>
          </p:nvSpPr>
          <p:spPr>
            <a:xfrm>
              <a:off x="5142452" y="3472674"/>
              <a:ext cx="343109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IC log</a:t>
              </a:r>
              <a:r>
                <a:rPr lang="en-US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fold changes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732944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9</TotalTime>
  <Words>1391</Words>
  <Application>Microsoft Office PowerPoint</Application>
  <PresentationFormat>Personalizado</PresentationFormat>
  <Paragraphs>258</Paragraphs>
  <Slides>7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9" baseType="lpstr">
      <vt:lpstr>Tema de Office</vt:lpstr>
      <vt:lpstr>Prism 8</vt:lpstr>
      <vt:lpstr>Presentación de PowerPoint</vt:lpstr>
      <vt:lpstr>Presentación de PowerPoint</vt:lpstr>
      <vt:lpstr>Supplementary Figure 2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CARLOS GARCIA CRUZ</dc:creator>
  <cp:lastModifiedBy>rgarcon</cp:lastModifiedBy>
  <cp:revision>6</cp:revision>
  <dcterms:created xsi:type="dcterms:W3CDTF">2023-08-11T20:43:48Z</dcterms:created>
  <dcterms:modified xsi:type="dcterms:W3CDTF">2023-11-20T15:51:28Z</dcterms:modified>
</cp:coreProperties>
</file>